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505" autoAdjust="0"/>
  </p:normalViewPr>
  <p:slideViewPr>
    <p:cSldViewPr>
      <p:cViewPr varScale="1">
        <p:scale>
          <a:sx n="127" d="100"/>
          <a:sy n="127" d="100"/>
        </p:scale>
        <p:origin x="1320" y="13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12FC8-F2CB-4106-B42C-7C0C541CC27A}" type="datetimeFigureOut">
              <a:rPr lang="en-US" smtClean="0"/>
              <a:t>1/22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15F4B-4B98-430E-AA24-DB46256B5CD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90006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12FC8-F2CB-4106-B42C-7C0C541CC27A}" type="datetimeFigureOut">
              <a:rPr lang="en-US" smtClean="0"/>
              <a:t>1/22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15F4B-4B98-430E-AA24-DB46256B5CD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888396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12FC8-F2CB-4106-B42C-7C0C541CC27A}" type="datetimeFigureOut">
              <a:rPr lang="en-US" smtClean="0"/>
              <a:t>1/22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15F4B-4B98-430E-AA24-DB46256B5CD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401941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12FC8-F2CB-4106-B42C-7C0C541CC27A}" type="datetimeFigureOut">
              <a:rPr lang="en-US" smtClean="0"/>
              <a:t>1/22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15F4B-4B98-430E-AA24-DB46256B5CD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34028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12FC8-F2CB-4106-B42C-7C0C541CC27A}" type="datetimeFigureOut">
              <a:rPr lang="en-US" smtClean="0"/>
              <a:t>1/22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15F4B-4B98-430E-AA24-DB46256B5CD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71753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12FC8-F2CB-4106-B42C-7C0C541CC27A}" type="datetimeFigureOut">
              <a:rPr lang="en-US" smtClean="0"/>
              <a:t>1/22/2019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15F4B-4B98-430E-AA24-DB46256B5CD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213302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12FC8-F2CB-4106-B42C-7C0C541CC27A}" type="datetimeFigureOut">
              <a:rPr lang="en-US" smtClean="0"/>
              <a:t>1/22/2019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15F4B-4B98-430E-AA24-DB46256B5CD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364090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12FC8-F2CB-4106-B42C-7C0C541CC27A}" type="datetimeFigureOut">
              <a:rPr lang="en-US" smtClean="0"/>
              <a:t>1/22/2019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15F4B-4B98-430E-AA24-DB46256B5CD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863523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12FC8-F2CB-4106-B42C-7C0C541CC27A}" type="datetimeFigureOut">
              <a:rPr lang="en-US" smtClean="0"/>
              <a:t>1/22/2019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15F4B-4B98-430E-AA24-DB46256B5CD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007105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12FC8-F2CB-4106-B42C-7C0C541CC27A}" type="datetimeFigureOut">
              <a:rPr lang="en-US" smtClean="0"/>
              <a:t>1/22/2019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15F4B-4B98-430E-AA24-DB46256B5CD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963465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12FC8-F2CB-4106-B42C-7C0C541CC27A}" type="datetimeFigureOut">
              <a:rPr lang="en-US" smtClean="0"/>
              <a:t>1/22/2019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15F4B-4B98-430E-AA24-DB46256B5CD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11126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112FC8-F2CB-4106-B42C-7C0C541CC27A}" type="datetimeFigureOut">
              <a:rPr lang="en-US" smtClean="0"/>
              <a:t>1/22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815F4B-4B98-430E-AA24-DB46256B5CD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433391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 txBox="1">
            <a:spLocks/>
          </p:cNvSpPr>
          <p:nvPr/>
        </p:nvSpPr>
        <p:spPr>
          <a:xfrm>
            <a:off x="609600" y="136168"/>
            <a:ext cx="8229600" cy="556727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70000" lnSpcReduction="200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800" b="1" dirty="0"/>
              <a:t>S1 Fig. </a:t>
            </a:r>
            <a:r>
              <a:rPr lang="en-US" sz="2800" dirty="0"/>
              <a:t>Quality Metrics for RNA-seq: Examples of FASTQC plots After Trimming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848100" y="679048"/>
            <a:ext cx="1447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RWPE-1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48100" y="3476798"/>
            <a:ext cx="1447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/>
              <a:t>CAsE</a:t>
            </a:r>
            <a:r>
              <a:rPr lang="en-US" sz="1200" dirty="0"/>
              <a:t>-PE</a:t>
            </a: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6000" y="3754481"/>
            <a:ext cx="4572000" cy="258924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6000" y="969210"/>
            <a:ext cx="4572000" cy="25082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DF119B2E-6A71-4EF1-86EF-1BE51AF98C75}"/>
              </a:ext>
            </a:extLst>
          </p:cNvPr>
          <p:cNvSpPr txBox="1"/>
          <p:nvPr/>
        </p:nvSpPr>
        <p:spPr>
          <a:xfrm rot="16200000">
            <a:off x="1147033" y="1824767"/>
            <a:ext cx="15804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Phred</a:t>
            </a:r>
            <a:r>
              <a:rPr lang="en-US" dirty="0"/>
              <a:t> Score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DE2C050-B178-432E-A102-2359E48B67C1}"/>
              </a:ext>
            </a:extLst>
          </p:cNvPr>
          <p:cNvSpPr txBox="1"/>
          <p:nvPr/>
        </p:nvSpPr>
        <p:spPr>
          <a:xfrm rot="16200000">
            <a:off x="1147034" y="4663901"/>
            <a:ext cx="15804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Phred</a:t>
            </a:r>
            <a:r>
              <a:rPr lang="en-US" dirty="0"/>
              <a:t> Score</a:t>
            </a:r>
          </a:p>
        </p:txBody>
      </p:sp>
    </p:spTree>
    <p:extLst>
      <p:ext uri="{BB962C8B-B14F-4D97-AF65-F5344CB8AC3E}">
        <p14:creationId xmlns:p14="http://schemas.microsoft.com/office/powerpoint/2010/main" val="27351650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30</TotalTime>
  <Words>20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Social &amp; Scientific Systems,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BS-seq analysis</dc:title>
  <dc:creator>itsupport</dc:creator>
  <cp:lastModifiedBy>Merrick, Alex (NIH/NIEHS) [E]</cp:lastModifiedBy>
  <cp:revision>70</cp:revision>
  <dcterms:created xsi:type="dcterms:W3CDTF">2013-12-16T20:49:44Z</dcterms:created>
  <dcterms:modified xsi:type="dcterms:W3CDTF">2019-01-22T17:33:48Z</dcterms:modified>
</cp:coreProperties>
</file>